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2" d="100"/>
          <a:sy n="62" d="100"/>
        </p:scale>
        <p:origin x="-2214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312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7713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0263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0494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389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2831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3931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7863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2437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2199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2223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GB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GB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68660-F230-4678-AA09-3B3390EF2EC9}" type="datetimeFigureOut">
              <a:rPr lang="en-GB" smtClean="0"/>
              <a:t>08/11/2016</a:t>
            </a:fld>
            <a:endParaRPr lang="en-GB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2697B8-4540-4B73-AFC3-2A6241350BD6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7302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3" descr="RES-08.tif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84" t="3165" r="-5000" b="-633"/>
          <a:stretch/>
        </p:blipFill>
        <p:spPr bwMode="auto">
          <a:xfrm>
            <a:off x="1269681" y="864607"/>
            <a:ext cx="2772000" cy="27720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CasellaDiTesto 4"/>
          <p:cNvSpPr txBox="1"/>
          <p:nvPr/>
        </p:nvSpPr>
        <p:spPr>
          <a:xfrm rot="16200000">
            <a:off x="741470" y="2420269"/>
            <a:ext cx="849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it-IT" sz="8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CasellaDiTesto 5"/>
          <p:cNvSpPr txBox="1"/>
          <p:nvPr/>
        </p:nvSpPr>
        <p:spPr>
          <a:xfrm rot="16200000">
            <a:off x="738712" y="1109725"/>
            <a:ext cx="849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it-IT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 rot="16200000">
            <a:off x="738516" y="3068341"/>
            <a:ext cx="849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it-IT" sz="800" dirty="0" err="1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800" dirty="0">
                <a:latin typeface="Symbol" panose="05050102010706020507" pitchFamily="18" charset="2"/>
                <a:cs typeface="Arial" panose="020B0604020202020204" pitchFamily="34" charset="0"/>
              </a:rPr>
              <a:t> / </a:t>
            </a:r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P2</a:t>
            </a:r>
            <a:endParaRPr lang="it-IT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 rot="16200000">
            <a:off x="738516" y="1757797"/>
            <a:ext cx="849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PP2</a:t>
            </a:r>
            <a:endParaRPr lang="it-IT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1284083" y="648583"/>
            <a:ext cx="849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E-</a:t>
            </a:r>
            <a:r>
              <a:rPr lang="it-IT" sz="900" dirty="0" err="1">
                <a:latin typeface="Arial" panose="020B0604020202020204" pitchFamily="34" charset="0"/>
                <a:cs typeface="Arial" panose="020B0604020202020204" pitchFamily="34" charset="0"/>
              </a:rPr>
              <a:t>Cadherin</a:t>
            </a:r>
            <a:endParaRPr lang="it-IT" sz="9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2133778" y="648583"/>
            <a:ext cx="849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  <a:endParaRPr lang="it-IT" sz="9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3084283" y="648583"/>
            <a:ext cx="8496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endParaRPr lang="it-IT" sz="9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2" name="CasellaDiTesto 2"/>
          <p:cNvSpPr txBox="1">
            <a:spLocks noChangeArrowheads="1"/>
          </p:cNvSpPr>
          <p:nvPr/>
        </p:nvSpPr>
        <p:spPr bwMode="auto">
          <a:xfrm>
            <a:off x="1025960" y="433852"/>
            <a:ext cx="2984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400" b="1" dirty="0">
                <a:latin typeface="Arial" charset="0"/>
              </a:rPr>
              <a:t>A</a:t>
            </a:r>
          </a:p>
        </p:txBody>
      </p:sp>
      <p:sp>
        <p:nvSpPr>
          <p:cNvPr id="13" name="CasellaDiTesto 2"/>
          <p:cNvSpPr txBox="1">
            <a:spLocks noChangeArrowheads="1"/>
          </p:cNvSpPr>
          <p:nvPr/>
        </p:nvSpPr>
        <p:spPr bwMode="auto">
          <a:xfrm>
            <a:off x="4401721" y="433852"/>
            <a:ext cx="2984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400" b="1" dirty="0">
                <a:latin typeface="Arial" charset="0"/>
              </a:rPr>
              <a:t>B</a:t>
            </a:r>
          </a:p>
        </p:txBody>
      </p:sp>
      <p:pic>
        <p:nvPicPr>
          <p:cNvPr id="14" name="Immagine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1721" y="828303"/>
            <a:ext cx="1995882" cy="1338128"/>
          </a:xfrm>
          <a:prstGeom prst="rect">
            <a:avLst/>
          </a:prstGeom>
        </p:spPr>
      </p:pic>
      <p:pic>
        <p:nvPicPr>
          <p:cNvPr id="15" name="Immagin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2063" y="2370495"/>
            <a:ext cx="1995882" cy="1338128"/>
          </a:xfrm>
          <a:prstGeom prst="rect">
            <a:avLst/>
          </a:prstGeom>
        </p:spPr>
      </p:pic>
      <p:sp>
        <p:nvSpPr>
          <p:cNvPr id="16" name="CasellaDiTesto 15"/>
          <p:cNvSpPr txBox="1"/>
          <p:nvPr/>
        </p:nvSpPr>
        <p:spPr>
          <a:xfrm>
            <a:off x="5021090" y="2253656"/>
            <a:ext cx="849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 err="1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  <a:endParaRPr lang="it-IT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5022563" y="768560"/>
            <a:ext cx="8496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-</a:t>
            </a:r>
            <a:r>
              <a:rPr lang="it-IT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dherin</a:t>
            </a:r>
            <a:endParaRPr lang="it-IT" sz="8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 rot="16200000">
            <a:off x="3953246" y="1340645"/>
            <a:ext cx="9953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7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it-IT" sz="7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4004077" y="2925638"/>
            <a:ext cx="9953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 err="1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7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endParaRPr lang="it-IT" sz="7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5226829" y="3525789"/>
            <a:ext cx="8496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it-IT" sz="7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4507850" y="3525789"/>
            <a:ext cx="8496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it-IT" sz="7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2" name="CasellaDiTesto 21"/>
          <p:cNvSpPr txBox="1"/>
          <p:nvPr/>
        </p:nvSpPr>
        <p:spPr>
          <a:xfrm>
            <a:off x="5681366" y="3525789"/>
            <a:ext cx="657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it-IT" sz="700" dirty="0" smtClean="0">
                <a:latin typeface="Symbol" panose="05050102010706020507" pitchFamily="18" charset="2"/>
                <a:cs typeface="Arial" panose="020B0604020202020204" pitchFamily="34" charset="0"/>
              </a:rPr>
              <a:t>b/</a:t>
            </a:r>
          </a:p>
          <a:p>
            <a:pPr algn="ctr"/>
            <a:r>
              <a:rPr lang="it-IT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P2</a:t>
            </a:r>
            <a:endParaRPr lang="it-IT" sz="7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3" name="CasellaDiTesto 22"/>
          <p:cNvSpPr txBox="1"/>
          <p:nvPr/>
        </p:nvSpPr>
        <p:spPr>
          <a:xfrm>
            <a:off x="5114874" y="3525789"/>
            <a:ext cx="36222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PP2</a:t>
            </a:r>
            <a:endParaRPr lang="it-IT" sz="7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5199891" y="1983488"/>
            <a:ext cx="8496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it-IT" sz="7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5" name="CasellaDiTesto 24"/>
          <p:cNvSpPr txBox="1"/>
          <p:nvPr/>
        </p:nvSpPr>
        <p:spPr>
          <a:xfrm>
            <a:off x="4485614" y="1983488"/>
            <a:ext cx="8496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it-IT" sz="7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5620837" y="1983488"/>
            <a:ext cx="7391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it-IT" sz="700" dirty="0" smtClean="0">
                <a:latin typeface="Symbol" panose="05050102010706020507" pitchFamily="18" charset="2"/>
                <a:cs typeface="Arial" panose="020B0604020202020204" pitchFamily="34" charset="0"/>
              </a:rPr>
              <a:t>b/</a:t>
            </a:r>
          </a:p>
          <a:p>
            <a:pPr algn="ctr"/>
            <a:r>
              <a:rPr lang="it-IT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P2</a:t>
            </a:r>
            <a:endParaRPr lang="it-IT" sz="7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5028501" y="1983488"/>
            <a:ext cx="4946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PP2</a:t>
            </a:r>
            <a:endParaRPr lang="it-IT" sz="7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>
            <a:off x="332656" y="8615481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0938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3</Words>
  <Application>Microsoft Office PowerPoint</Application>
  <PresentationFormat>Presentazione su schermo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labr3</dc:creator>
  <cp:lastModifiedBy>labr3</cp:lastModifiedBy>
  <cp:revision>2</cp:revision>
  <dcterms:created xsi:type="dcterms:W3CDTF">2016-07-27T09:56:50Z</dcterms:created>
  <dcterms:modified xsi:type="dcterms:W3CDTF">2016-11-08T13:33:33Z</dcterms:modified>
</cp:coreProperties>
</file>